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85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25" autoAdjust="0"/>
    <p:restoredTop sz="94660"/>
  </p:normalViewPr>
  <p:slideViewPr>
    <p:cSldViewPr snapToGrid="0">
      <p:cViewPr varScale="1">
        <p:scale>
          <a:sx n="83" d="100"/>
          <a:sy n="83" d="100"/>
        </p:scale>
        <p:origin x="595" y="11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BF3D538-32D6-404B-95B5-477E588CB057}" type="datetimeFigureOut">
              <a:rPr lang="en-US" smtClean="0"/>
              <a:t>2022-07-0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598968E-2A7C-4605-9F1B-16A337BDEC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777542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E9CBCC-7722-4F32-9C33-DBD8E41BB1CE}" type="datetimeFigureOut">
              <a:rPr lang="en-US" smtClean="0"/>
              <a:t>2022-07-0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5D5ACB-B9F4-48CB-B035-B24DB81E7E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07345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E9CBCC-7722-4F32-9C33-DBD8E41BB1CE}" type="datetimeFigureOut">
              <a:rPr lang="en-US" smtClean="0"/>
              <a:t>2022-07-0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5D5ACB-B9F4-48CB-B035-B24DB81E7E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66510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E9CBCC-7722-4F32-9C33-DBD8E41BB1CE}" type="datetimeFigureOut">
              <a:rPr lang="en-US" smtClean="0"/>
              <a:t>2022-07-0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5D5ACB-B9F4-48CB-B035-B24DB81E7E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52835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E9CBCC-7722-4F32-9C33-DBD8E41BB1CE}" type="datetimeFigureOut">
              <a:rPr lang="en-US" smtClean="0"/>
              <a:t>2022-07-0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5D5ACB-B9F4-48CB-B035-B24DB81E7E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47794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E9CBCC-7722-4F32-9C33-DBD8E41BB1CE}" type="datetimeFigureOut">
              <a:rPr lang="en-US" smtClean="0"/>
              <a:t>2022-07-0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5D5ACB-B9F4-48CB-B035-B24DB81E7E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58331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E9CBCC-7722-4F32-9C33-DBD8E41BB1CE}" type="datetimeFigureOut">
              <a:rPr lang="en-US" smtClean="0"/>
              <a:t>2022-07-0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5D5ACB-B9F4-48CB-B035-B24DB81E7E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88919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E9CBCC-7722-4F32-9C33-DBD8E41BB1CE}" type="datetimeFigureOut">
              <a:rPr lang="en-US" smtClean="0"/>
              <a:t>2022-07-0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5D5ACB-B9F4-48CB-B035-B24DB81E7E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32121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E9CBCC-7722-4F32-9C33-DBD8E41BB1CE}" type="datetimeFigureOut">
              <a:rPr lang="en-US" smtClean="0"/>
              <a:t>2022-07-0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5D5ACB-B9F4-48CB-B035-B24DB81E7E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96820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E9CBCC-7722-4F32-9C33-DBD8E41BB1CE}" type="datetimeFigureOut">
              <a:rPr lang="en-US" smtClean="0"/>
              <a:t>2022-07-0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5D5ACB-B9F4-48CB-B035-B24DB81E7E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25618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E9CBCC-7722-4F32-9C33-DBD8E41BB1CE}" type="datetimeFigureOut">
              <a:rPr lang="en-US" smtClean="0"/>
              <a:t>2022-07-0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5D5ACB-B9F4-48CB-B035-B24DB81E7E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06343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E9CBCC-7722-4F32-9C33-DBD8E41BB1CE}" type="datetimeFigureOut">
              <a:rPr lang="en-US" smtClean="0"/>
              <a:t>2022-07-0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5D5ACB-B9F4-48CB-B035-B24DB81E7E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73907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E9CBCC-7722-4F32-9C33-DBD8E41BB1CE}" type="datetimeFigureOut">
              <a:rPr lang="en-US" smtClean="0"/>
              <a:t>2022-07-0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5D5ACB-B9F4-48CB-B035-B24DB81E7E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87329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3200400" y="6251331"/>
            <a:ext cx="602589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Palatino Linotype" panose="02040502050505030304" pitchFamily="18" charset="0"/>
              </a:rPr>
              <a:t>Supplemental Table S1</a:t>
            </a:r>
            <a:r>
              <a:rPr lang="en-US" sz="1200" dirty="0">
                <a:latin typeface="Palatino Linotype" panose="02040502050505030304" pitchFamily="18" charset="0"/>
              </a:rPr>
              <a:t>: Spearman correlation analysis of SIV viral load and immune cell populations. R values are displayed. *p&lt;0.05.</a:t>
            </a:r>
          </a:p>
        </p:txBody>
      </p:sp>
      <p:grpSp>
        <p:nvGrpSpPr>
          <p:cNvPr id="8" name="Group 7">
            <a:extLst>
              <a:ext uri="{FF2B5EF4-FFF2-40B4-BE49-F238E27FC236}">
                <a16:creationId xmlns:a16="http://schemas.microsoft.com/office/drawing/2014/main" id="{08699401-7DC7-DAF2-786C-A4ADD0BC5855}"/>
              </a:ext>
            </a:extLst>
          </p:cNvPr>
          <p:cNvGrpSpPr/>
          <p:nvPr/>
        </p:nvGrpSpPr>
        <p:grpSpPr>
          <a:xfrm>
            <a:off x="1810512" y="-95929"/>
            <a:ext cx="7514971" cy="6422568"/>
            <a:chOff x="1810512" y="-95929"/>
            <a:chExt cx="7514971" cy="6422568"/>
          </a:xfrm>
        </p:grpSpPr>
        <p:graphicFrame>
          <p:nvGraphicFramePr>
            <p:cNvPr id="2" name="Object 1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746647999"/>
                </p:ext>
              </p:extLst>
            </p:nvPr>
          </p:nvGraphicFramePr>
          <p:xfrm>
            <a:off x="1810512" y="-60125"/>
            <a:ext cx="7514971" cy="6386764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2" imgW="4959429" imgH="4214162" progId="Prism8.Document">
                    <p:embed/>
                  </p:oleObj>
                </mc:Choice>
                <mc:Fallback>
                  <p:oleObj name="Prism 8" r:id="rId2" imgW="4959429" imgH="4214162" progId="Prism8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3"/>
                        <a:stretch>
                          <a:fillRect/>
                        </a:stretch>
                      </p:blipFill>
                      <p:spPr>
                        <a:xfrm>
                          <a:off x="1810512" y="-60125"/>
                          <a:ext cx="7514971" cy="6386764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A5E3E8B0-A9B6-FCD1-DE45-D6F9E27B70B3}"/>
                </a:ext>
              </a:extLst>
            </p:cNvPr>
            <p:cNvSpPr txBox="1"/>
            <p:nvPr/>
          </p:nvSpPr>
          <p:spPr>
            <a:xfrm>
              <a:off x="1810512" y="3357439"/>
              <a:ext cx="429371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400" b="1" dirty="0">
                  <a:latin typeface="Palatino Linotype" panose="02040502050505030304" pitchFamily="18" charset="0"/>
                </a:rPr>
                <a:t>*</a:t>
              </a:r>
              <a:endParaRPr lang="en-US" b="1" dirty="0">
                <a:latin typeface="Palatino Linotype" panose="02040502050505030304" pitchFamily="18" charset="0"/>
              </a:endParaRP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52EA84CD-798A-9F22-4EF0-4E94A914814E}"/>
                </a:ext>
              </a:extLst>
            </p:cNvPr>
            <p:cNvSpPr txBox="1"/>
            <p:nvPr/>
          </p:nvSpPr>
          <p:spPr>
            <a:xfrm>
              <a:off x="2239883" y="4130041"/>
              <a:ext cx="429371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400" b="1" dirty="0">
                  <a:latin typeface="Palatino Linotype" panose="02040502050505030304" pitchFamily="18" charset="0"/>
                </a:rPr>
                <a:t>*</a:t>
              </a:r>
              <a:endParaRPr lang="en-US" b="1" dirty="0">
                <a:latin typeface="Palatino Linotype" panose="02040502050505030304" pitchFamily="18" charset="0"/>
              </a:endParaRP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24D33CD8-FD08-CC8C-79B6-5F40CE54C5E2}"/>
                </a:ext>
              </a:extLst>
            </p:cNvPr>
            <p:cNvSpPr txBox="1"/>
            <p:nvPr/>
          </p:nvSpPr>
          <p:spPr>
            <a:xfrm>
              <a:off x="5286558" y="-95929"/>
              <a:ext cx="429371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400" b="1" dirty="0">
                  <a:latin typeface="Palatino Linotype" panose="02040502050505030304" pitchFamily="18" charset="0"/>
                </a:rPr>
                <a:t>*</a:t>
              </a:r>
              <a:endParaRPr lang="en-US" b="1" dirty="0">
                <a:latin typeface="Palatino Linotype" panose="02040502050505030304" pitchFamily="18" charset="0"/>
              </a:endParaRP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A545BC3B-3CC7-EBF6-D660-2DB72DA077FD}"/>
                </a:ext>
              </a:extLst>
            </p:cNvPr>
            <p:cNvSpPr txBox="1"/>
            <p:nvPr/>
          </p:nvSpPr>
          <p:spPr>
            <a:xfrm>
              <a:off x="6046702" y="283440"/>
              <a:ext cx="429371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400" b="1" dirty="0">
                  <a:latin typeface="Palatino Linotype" panose="02040502050505030304" pitchFamily="18" charset="0"/>
                </a:rPr>
                <a:t>*</a:t>
              </a:r>
              <a:endParaRPr lang="en-US" b="1" dirty="0">
                <a:latin typeface="Palatino Linotype" panose="0204050205050503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6321656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308</TotalTime>
  <Words>30</Words>
  <Application>Microsoft Office PowerPoint</Application>
  <PresentationFormat>Widescreen</PresentationFormat>
  <Paragraphs>5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Palatino Linotype</vt:lpstr>
      <vt:lpstr>Office Theme</vt:lpstr>
      <vt:lpstr>Prism 8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cTernan, Patrick</dc:creator>
  <cp:lastModifiedBy>Marija Sarcevic</cp:lastModifiedBy>
  <cp:revision>359</cp:revision>
  <dcterms:created xsi:type="dcterms:W3CDTF">2021-05-10T21:37:11Z</dcterms:created>
  <dcterms:modified xsi:type="dcterms:W3CDTF">2022-07-05T12:29:13Z</dcterms:modified>
</cp:coreProperties>
</file>